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50"/>
  </p:normalViewPr>
  <p:slideViewPr>
    <p:cSldViewPr snapToGrid="0">
      <p:cViewPr varScale="1">
        <p:scale>
          <a:sx n="120" d="100"/>
          <a:sy n="120" d="100"/>
        </p:scale>
        <p:origin x="25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BB2BF87-D0CB-1FEC-3F28-4B8F48DB42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ED7D9BAB-14F0-7286-BD2F-BE46590BE8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4B7CB83-BB7E-FF17-0FD1-4430B456C8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1EF5B-004E-9245-922F-9EFA1D7AFED3}" type="datetimeFigureOut">
              <a:rPr lang="de-DE" smtClean="0"/>
              <a:t>24.07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0794195-C1F2-7964-24A8-47A90A2D22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E25BD29-3035-931F-3AE8-DD3E03DE41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1EE66-C411-7B46-93F8-13406C6596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2947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069713-4DBE-1D5D-61D8-5CBF266164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05C66E2-A100-18DC-8312-C88EE6DD84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4A3717B-D625-BE8B-995B-230F164FB7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1EF5B-004E-9245-922F-9EFA1D7AFED3}" type="datetimeFigureOut">
              <a:rPr lang="de-DE" smtClean="0"/>
              <a:t>24.07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0F7B892-2BDB-33E2-18FC-C2CDC082EE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588921D-76F1-219D-A3B2-06AB0420E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1EE66-C411-7B46-93F8-13406C6596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83866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0A252424-D6B0-099E-D3F9-B8AC7400241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555A094-8A1D-D492-53CC-EB77478ECA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AE438E7-096F-2F7C-5BA0-37675DB53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1EF5B-004E-9245-922F-9EFA1D7AFED3}" type="datetimeFigureOut">
              <a:rPr lang="de-DE" smtClean="0"/>
              <a:t>24.07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1EE18ED-FFF4-FA90-9EF9-F819F0305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F3E951B-FF92-2E12-BEEF-BCC4D10A7B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1EE66-C411-7B46-93F8-13406C6596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89431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8B36FCF-DF53-7C01-E035-A00FFF5162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1C22D18-4E9E-077E-3FA0-DFA71DF3E1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2181394-7C7C-6B31-B58C-A218A120B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1EF5B-004E-9245-922F-9EFA1D7AFED3}" type="datetimeFigureOut">
              <a:rPr lang="de-DE" smtClean="0"/>
              <a:t>24.07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5FC2D5D-47F0-1C9B-1C97-5CA8850BDA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327E871-3A6A-198F-0012-85A3E8F459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1EE66-C411-7B46-93F8-13406C6596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2549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6FEC255-D233-5D65-2551-E77373B43E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820D2A8-995D-3857-8DC2-05E64B9853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A523978-EE33-3ED8-4E21-41B667926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1EF5B-004E-9245-922F-9EFA1D7AFED3}" type="datetimeFigureOut">
              <a:rPr lang="de-DE" smtClean="0"/>
              <a:t>24.07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B10712A-3D27-4B33-DB72-F920DDECD1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0524BC7-4410-F916-6AD3-CAFCA278AA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1EE66-C411-7B46-93F8-13406C6596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2743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23932F1-A72B-29B4-D110-2F9752E942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63A8242-F561-1F03-B452-7EBF99DEFD9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8B2C36F7-4A0D-4862-6CC4-7646BCD25B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C6F8CA9-3D09-63F1-59C1-077B787484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1EF5B-004E-9245-922F-9EFA1D7AFED3}" type="datetimeFigureOut">
              <a:rPr lang="de-DE" smtClean="0"/>
              <a:t>24.07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38F6390-4A16-5816-A8BE-59ED0346E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E7375AC-D993-E09B-8E8A-9A50D93312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1EE66-C411-7B46-93F8-13406C6596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3778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0DBC1C9-016B-1835-99D1-F0959347D4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B9146CC-16F1-D139-0143-A9888CE02D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C3F29F4-3E85-35F3-C027-0DEFF4165A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0495A787-1FB0-1D84-BEB1-640A9321D29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F6AA7787-A2DD-2E56-6B7A-EFCDF45792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A7F9AEA8-551F-DC32-EF0C-E36A3739A2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1EF5B-004E-9245-922F-9EFA1D7AFED3}" type="datetimeFigureOut">
              <a:rPr lang="de-DE" smtClean="0"/>
              <a:t>24.07.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FE88A8CB-ED38-E8E1-85E4-B5C06AABC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C0985AE5-86F8-43A2-5317-11A4794867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1EE66-C411-7B46-93F8-13406C6596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6240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7394347-ED64-3634-45F6-406B28EDDC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BB122FCB-E8B9-A283-17BB-8DDBC8B9D6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1EF5B-004E-9245-922F-9EFA1D7AFED3}" type="datetimeFigureOut">
              <a:rPr lang="de-DE" smtClean="0"/>
              <a:t>24.07.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B2EC7C14-7C11-7155-604D-61AABB398E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F58F0911-D9A1-A8F1-51A5-01F1789F7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1EE66-C411-7B46-93F8-13406C6596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588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5893F383-5D49-168A-7FDA-6C78D5E38B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1EF5B-004E-9245-922F-9EFA1D7AFED3}" type="datetimeFigureOut">
              <a:rPr lang="de-DE" smtClean="0"/>
              <a:t>24.07.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F29EDF9F-4810-02A6-8EE1-422A769CE7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04AFD2B-862C-029E-DC67-F5372CCDC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1EE66-C411-7B46-93F8-13406C6596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0349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B792F79-14CC-AC80-D593-BA1E1B6F97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925D830-0C9E-E669-2B1F-B35A581188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2F33827-A5BF-69BC-B938-F17857EB9D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BC6B3A8-8925-D57B-424E-2EF1935102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1EF5B-004E-9245-922F-9EFA1D7AFED3}" type="datetimeFigureOut">
              <a:rPr lang="de-DE" smtClean="0"/>
              <a:t>24.07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123C985-1B14-CD3F-69EE-1BC0F1197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846F85A-25C9-FEA6-263B-048D52A2E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1EE66-C411-7B46-93F8-13406C6596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2719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F66B52D-D833-FD17-025D-7C7E5F15E1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544BB9E3-C393-154F-A6E4-4E8326DDEC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968B594-E0FA-D8BB-D6D8-58B7F4BCFE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F4E34EE-30E6-5835-8333-340A0C0E4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1EF5B-004E-9245-922F-9EFA1D7AFED3}" type="datetimeFigureOut">
              <a:rPr lang="de-DE" smtClean="0"/>
              <a:t>24.07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D47F875-CC98-873B-A476-9DB2A87A3D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A2F6AEA-9698-1407-DAC2-23A815C9A3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1EE66-C411-7B46-93F8-13406C6596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0480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6C13B56F-909F-EC29-1193-415AB2C030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7A54F2F-17A0-E408-E6F2-1D0BDB6440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D2084C3-7122-362F-6DC4-B689E129465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531EF5B-004E-9245-922F-9EFA1D7AFED3}" type="datetimeFigureOut">
              <a:rPr lang="de-DE" smtClean="0"/>
              <a:t>24.07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D826FFF-8A2C-F1DF-1770-F5B637AD27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A18CF1C-C145-609F-CBF5-5DF2E3376E5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7E1EE66-C411-7B46-93F8-13406C6596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3335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B1D0B859-2D58-0FF4-DB75-98E5C4F17C5E}"/>
              </a:ext>
            </a:extLst>
          </p:cNvPr>
          <p:cNvSpPr txBox="1"/>
          <p:nvPr/>
        </p:nvSpPr>
        <p:spPr>
          <a:xfrm>
            <a:off x="779930" y="4910461"/>
            <a:ext cx="1063214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4.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ssociation between DOAC plasma level and stroke severity at admission. Scatter plot showing the relationship between DOAC plasma levels (ng/ml) and NIHSS scores at hospital admission. Each dot represents one patient. A decreasing trend in stroke severity with increasing DOAC levels is illustrated by the locally weighted regression (LOESS) curve. This non-parametric association was statistically significant (Spearman’s </a:t>
            </a:r>
            <a:r>
              <a:rPr lang="de-DE" sz="1800" kern="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ρ</a:t>
            </a:r>
            <a:r>
              <a:rPr lang="en-US" sz="18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= -0.263, p &lt;0.001).</a:t>
            </a:r>
            <a:r>
              <a:rPr lang="de-DE" dirty="0">
                <a:effectLst/>
              </a:rPr>
              <a:t> </a:t>
            </a:r>
            <a:endParaRPr lang="de-DE" dirty="0"/>
          </a:p>
        </p:txBody>
      </p:sp>
      <p:pic>
        <p:nvPicPr>
          <p:cNvPr id="7" name="Drawing 0">
            <a:extLst>
              <a:ext uri="{FF2B5EF4-FFF2-40B4-BE49-F238E27FC236}">
                <a16:creationId xmlns:a16="http://schemas.microsoft.com/office/drawing/2014/main" id="{0C39BBB2-2306-3F6A-AA1C-41AD38CE88A9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2594344" y="470211"/>
            <a:ext cx="7038754" cy="41974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1581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04FC5AF0-4DB1-B7D7-9974-4F594E522F0A}"/>
              </a:ext>
            </a:extLst>
          </p:cNvPr>
          <p:cNvSpPr txBox="1"/>
          <p:nvPr/>
        </p:nvSpPr>
        <p:spPr>
          <a:xfrm>
            <a:off x="1021977" y="966858"/>
            <a:ext cx="10148046" cy="4657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able 4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pearman’s rank correlation between DOAC plasma level and stroke severity at admission </a:t>
            </a:r>
            <a:endParaRPr lang="de-DE" sz="1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Tabelle 7">
            <a:extLst>
              <a:ext uri="{FF2B5EF4-FFF2-40B4-BE49-F238E27FC236}">
                <a16:creationId xmlns:a16="http://schemas.microsoft.com/office/drawing/2014/main" id="{873DD640-AC46-8C4F-CA61-F575041B22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038269"/>
              </p:ext>
            </p:extLst>
          </p:nvPr>
        </p:nvGraphicFramePr>
        <p:xfrm>
          <a:off x="1021978" y="2122715"/>
          <a:ext cx="10148043" cy="3768431"/>
        </p:xfrm>
        <a:graphic>
          <a:graphicData uri="http://schemas.openxmlformats.org/drawingml/2006/table">
            <a:tbl>
              <a:tblPr firstRow="1" firstCol="1" bandRow="1"/>
              <a:tblGrid>
                <a:gridCol w="2114175">
                  <a:extLst>
                    <a:ext uri="{9D8B030D-6E8A-4147-A177-3AD203B41FA5}">
                      <a16:colId xmlns:a16="http://schemas.microsoft.com/office/drawing/2014/main" val="3694469205"/>
                    </a:ext>
                  </a:extLst>
                </a:gridCol>
                <a:gridCol w="2114175">
                  <a:extLst>
                    <a:ext uri="{9D8B030D-6E8A-4147-A177-3AD203B41FA5}">
                      <a16:colId xmlns:a16="http://schemas.microsoft.com/office/drawing/2014/main" val="2602460596"/>
                    </a:ext>
                  </a:extLst>
                </a:gridCol>
                <a:gridCol w="1973231">
                  <a:extLst>
                    <a:ext uri="{9D8B030D-6E8A-4147-A177-3AD203B41FA5}">
                      <a16:colId xmlns:a16="http://schemas.microsoft.com/office/drawing/2014/main" val="2584433439"/>
                    </a:ext>
                  </a:extLst>
                </a:gridCol>
                <a:gridCol w="1973231">
                  <a:extLst>
                    <a:ext uri="{9D8B030D-6E8A-4147-A177-3AD203B41FA5}">
                      <a16:colId xmlns:a16="http://schemas.microsoft.com/office/drawing/2014/main" val="986153550"/>
                    </a:ext>
                  </a:extLst>
                </a:gridCol>
                <a:gridCol w="1973231">
                  <a:extLst>
                    <a:ext uri="{9D8B030D-6E8A-4147-A177-3AD203B41FA5}">
                      <a16:colId xmlns:a16="http://schemas.microsoft.com/office/drawing/2014/main" val="3405010558"/>
                    </a:ext>
                  </a:extLst>
                </a:gridCol>
              </a:tblGrid>
              <a:tr h="472540">
                <a:tc gridSpan="5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38700834"/>
                  </a:ext>
                </a:extLst>
              </a:tr>
              <a:tr h="611145">
                <a:tc gridSpan="3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15293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OAC level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 anchor="b">
                    <a:lnL>
                      <a:noFill/>
                    </a:lnL>
                    <a:lnR w="1270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15293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IHSS score at admission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 anchor="b">
                    <a:lnL w="1270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15293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1961222"/>
                  </a:ext>
                </a:extLst>
              </a:tr>
              <a:tr h="335725">
                <a:tc rowSpan="6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pearman’s Rho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15293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5293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0E0E0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OAC level (ng/ml)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15293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0E0E0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rrelation coefficient 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15293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0E0E0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000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>
                      <a:noFill/>
                    </a:lnL>
                    <a:lnR w="1270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15293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B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0.263</a:t>
                      </a:r>
                      <a:r>
                        <a:rPr lang="de-DE" sz="850" kern="0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 w="1270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15293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0425364"/>
                  </a:ext>
                </a:extLst>
              </a:tr>
              <a:tr h="335725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i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(two-tailed)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0E0E0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>
                      <a:noFill/>
                    </a:lnL>
                    <a:lnR w="1270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B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 w="1270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3354859"/>
                  </a:ext>
                </a:extLst>
              </a:tr>
              <a:tr h="335725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0E0E0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69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>
                      <a:noFill/>
                    </a:lnL>
                    <a:lnR w="1270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9F9FB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69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 w="1270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9F9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0814534"/>
                  </a:ext>
                </a:extLst>
              </a:tr>
              <a:tr h="335725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IHSS score at admission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15293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0E0E0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rrelation coefficient 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0E0E0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0.263</a:t>
                      </a:r>
                      <a:r>
                        <a:rPr lang="de-DE" sz="850" kern="0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>
                      <a:noFill/>
                    </a:lnL>
                    <a:lnR w="1270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B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000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 w="1270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0125762"/>
                  </a:ext>
                </a:extLst>
              </a:tr>
              <a:tr h="335725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i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(two-tailed)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0E0E0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>
                      <a:noFill/>
                    </a:lnL>
                    <a:lnR w="1270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B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 w="1270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0722779"/>
                  </a:ext>
                </a:extLst>
              </a:tr>
              <a:tr h="335725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5293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0E0E0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69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>
                      <a:noFill/>
                    </a:lnL>
                    <a:lnR w="1270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5293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B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de-DE" sz="85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69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 w="1270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5293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4775755"/>
                  </a:ext>
                </a:extLst>
              </a:tr>
              <a:tr h="670396">
                <a:tc gridSpan="5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85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*p</a:t>
                      </a:r>
                      <a:r>
                        <a:rPr lang="en-US" sz="8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&lt;0.01 (two-tailed) indicates statistical significance.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15293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7772027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360265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9</Words>
  <Application>Microsoft Macintosh PowerPoint</Application>
  <PresentationFormat>Breitbild</PresentationFormat>
  <Paragraphs>28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oreen Pommeranz</dc:creator>
  <cp:lastModifiedBy>Doreen Pommeranz</cp:lastModifiedBy>
  <cp:revision>1</cp:revision>
  <dcterms:created xsi:type="dcterms:W3CDTF">2025-07-24T08:38:29Z</dcterms:created>
  <dcterms:modified xsi:type="dcterms:W3CDTF">2025-07-24T08:42:56Z</dcterms:modified>
</cp:coreProperties>
</file>